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102475" cy="938847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B1E13D-5DD5-4A09-8AA5-8DBFBE79C52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E8DD64-6220-4C74-A991-C1984B0453D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8D391E2-CC43-45A2-AC62-93DAE83CF84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2C9553-7F1A-479E-9CD0-32FD145F0B1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F97C44-BC7F-44A7-B53A-1EA28DE33E1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9AA97F-4EB4-415E-809D-6DCD9820749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ACB3B42-1132-4B2D-9E16-6EF81C8462D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3A6667-7010-4760-BB09-9DBCCE64702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AA7980-727D-4FD0-9403-130F2FA654A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8C9D5B-DF56-4D4F-B741-8469D96E57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27DD2D-5595-4C01-B618-5BE2D4DC86A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FC5F2A4-5020-4906-8D5D-C47F22471F9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s-MX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s-MX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C96E61D-5BC7-4972-BAB1-50F81B803FF5}" type="slidenum">
              <a:rPr b="0" lang="es-MX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28"/>
          <p:cNvGrpSpPr/>
          <p:nvPr/>
        </p:nvGrpSpPr>
        <p:grpSpPr>
          <a:xfrm>
            <a:off x="2104920" y="1585800"/>
            <a:ext cx="3038040" cy="3057120"/>
            <a:chOff x="2104920" y="1585800"/>
            <a:chExt cx="3038040" cy="3057120"/>
          </a:xfrm>
        </p:grpSpPr>
        <p:grpSp>
          <p:nvGrpSpPr>
            <p:cNvPr id="42" name="Group 10"/>
            <p:cNvGrpSpPr/>
            <p:nvPr/>
          </p:nvGrpSpPr>
          <p:grpSpPr>
            <a:xfrm>
              <a:off x="2104920" y="1585800"/>
              <a:ext cx="2963520" cy="2987640"/>
              <a:chOff x="2104920" y="1585800"/>
              <a:chExt cx="2963520" cy="2987640"/>
            </a:xfrm>
          </p:grpSpPr>
          <p:pic>
            <p:nvPicPr>
              <p:cNvPr id="43" name="Picture 6" descr="SDF1 AL 488 40X 1_DSP.tif"/>
              <p:cNvPicPr/>
              <p:nvPr/>
            </p:nvPicPr>
            <p:blipFill>
              <a:blip r:embed="rId1"/>
              <a:stretch/>
            </p:blipFill>
            <p:spPr>
              <a:xfrm>
                <a:off x="2104920" y="1585800"/>
                <a:ext cx="1450440" cy="144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4" name="Picture 7" descr="SDF1 AL 488 40X 1_DSP.tif"/>
              <p:cNvPicPr/>
              <p:nvPr/>
            </p:nvPicPr>
            <p:blipFill>
              <a:blip r:embed="rId2"/>
              <a:stretch/>
            </p:blipFill>
            <p:spPr>
              <a:xfrm>
                <a:off x="3618000" y="1585800"/>
                <a:ext cx="1450440" cy="144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5" name="Picture 8" descr="SDF1 AL 488 40X 1_DSP.tif"/>
              <p:cNvPicPr/>
              <p:nvPr/>
            </p:nvPicPr>
            <p:blipFill>
              <a:blip r:embed="rId3"/>
              <a:stretch/>
            </p:blipFill>
            <p:spPr>
              <a:xfrm>
                <a:off x="2104920" y="3123720"/>
                <a:ext cx="1450440" cy="1449720"/>
              </a:xfrm>
              <a:prstGeom prst="rect">
                <a:avLst/>
              </a:prstGeom>
              <a:ln w="0">
                <a:noFill/>
              </a:ln>
            </p:spPr>
          </p:pic>
          <p:pic>
            <p:nvPicPr>
              <p:cNvPr id="46" name="Picture 9" descr="SDF1 AL 488 40X 1_DSP.tif"/>
              <p:cNvPicPr/>
              <p:nvPr/>
            </p:nvPicPr>
            <p:blipFill>
              <a:blip r:embed="rId4"/>
              <a:stretch/>
            </p:blipFill>
            <p:spPr>
              <a:xfrm>
                <a:off x="3618000" y="3123720"/>
                <a:ext cx="1450440" cy="1449720"/>
              </a:xfrm>
              <a:prstGeom prst="rect">
                <a:avLst/>
              </a:prstGeom>
              <a:ln w="0">
                <a:noFill/>
              </a:ln>
            </p:spPr>
          </p:pic>
        </p:grpSp>
        <p:sp>
          <p:nvSpPr>
            <p:cNvPr id="47" name="TextBox 27"/>
            <p:cNvSpPr/>
            <p:nvPr/>
          </p:nvSpPr>
          <p:spPr>
            <a:xfrm>
              <a:off x="3036600" y="1606680"/>
              <a:ext cx="55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80ff00"/>
                  </a:solidFill>
                  <a:latin typeface="Times New Roman"/>
                  <a:ea typeface="MS PGothic"/>
                </a:rPr>
                <a:t>HIF-1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TextBox 28"/>
            <p:cNvSpPr/>
            <p:nvPr/>
          </p:nvSpPr>
          <p:spPr>
            <a:xfrm>
              <a:off x="2108520" y="277992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N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TextBox 20"/>
            <p:cNvSpPr/>
            <p:nvPr/>
          </p:nvSpPr>
          <p:spPr>
            <a:xfrm>
              <a:off x="3634200" y="2774520"/>
              <a:ext cx="42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AL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Straight Connector 7"/>
            <p:cNvSpPr/>
            <p:nvPr/>
          </p:nvSpPr>
          <p:spPr>
            <a:xfrm>
              <a:off x="2130120" y="2965320"/>
              <a:ext cx="306360" cy="0"/>
            </a:xfrm>
            <a:prstGeom prst="line">
              <a:avLst/>
            </a:prstGeom>
            <a:ln w="2844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Straight Connector 8"/>
            <p:cNvSpPr/>
            <p:nvPr/>
          </p:nvSpPr>
          <p:spPr>
            <a:xfrm>
              <a:off x="3628800" y="2957400"/>
              <a:ext cx="323640" cy="0"/>
            </a:xfrm>
            <a:prstGeom prst="line">
              <a:avLst/>
            </a:prstGeom>
            <a:ln w="2844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TextBox 43"/>
            <p:cNvSpPr/>
            <p:nvPr/>
          </p:nvSpPr>
          <p:spPr>
            <a:xfrm>
              <a:off x="4558320" y="4289040"/>
              <a:ext cx="584640" cy="353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CoCl</a:t>
              </a:r>
              <a:r>
                <a:rPr b="0" lang="en-US" sz="1000" spc="-1" strike="noStrike" baseline="-25000">
                  <a:solidFill>
                    <a:srgbClr val="ffffff"/>
                  </a:solidFill>
                  <a:latin typeface="Times New Roman"/>
                  <a:ea typeface="MS PGothic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100μM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TextBox 35"/>
            <p:cNvSpPr/>
            <p:nvPr/>
          </p:nvSpPr>
          <p:spPr>
            <a:xfrm>
              <a:off x="3034800" y="4271040"/>
              <a:ext cx="584640" cy="3538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CoCl</a:t>
              </a:r>
              <a:r>
                <a:rPr b="0" lang="en-US" sz="1000" spc="-1" strike="noStrike" baseline="-25000">
                  <a:solidFill>
                    <a:srgbClr val="ffffff"/>
                  </a:solidFill>
                  <a:latin typeface="Times New Roman"/>
                  <a:ea typeface="MS PGothic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100μM 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TextBox 60"/>
            <p:cNvSpPr/>
            <p:nvPr/>
          </p:nvSpPr>
          <p:spPr>
            <a:xfrm>
              <a:off x="2125440" y="4303080"/>
              <a:ext cx="468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NBM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TextBox 72"/>
            <p:cNvSpPr/>
            <p:nvPr/>
          </p:nvSpPr>
          <p:spPr>
            <a:xfrm>
              <a:off x="3131280" y="2840040"/>
              <a:ext cx="478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TextBox 27"/>
            <p:cNvSpPr/>
            <p:nvPr/>
          </p:nvSpPr>
          <p:spPr>
            <a:xfrm>
              <a:off x="4553280" y="1598040"/>
              <a:ext cx="55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80ff00"/>
                  </a:solidFill>
                  <a:latin typeface="Times New Roman"/>
                  <a:ea typeface="MS PGothic"/>
                </a:rPr>
                <a:t>HIF-1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TextBox 27"/>
            <p:cNvSpPr/>
            <p:nvPr/>
          </p:nvSpPr>
          <p:spPr>
            <a:xfrm>
              <a:off x="3062520" y="3155400"/>
              <a:ext cx="557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80ff00"/>
                  </a:solidFill>
                  <a:latin typeface="Times New Roman"/>
                  <a:ea typeface="MS PGothic"/>
                </a:rPr>
                <a:t>HIF-1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TextBox 27"/>
            <p:cNvSpPr/>
            <p:nvPr/>
          </p:nvSpPr>
          <p:spPr>
            <a:xfrm>
              <a:off x="4566600" y="3143520"/>
              <a:ext cx="475200" cy="398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80ff00"/>
                  </a:solidFill>
                  <a:latin typeface="Times New Roman"/>
                  <a:ea typeface="MS PGothic"/>
                </a:rPr>
                <a:t>HIF-1α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TextBox 61"/>
            <p:cNvSpPr/>
            <p:nvPr/>
          </p:nvSpPr>
          <p:spPr>
            <a:xfrm>
              <a:off x="3624480" y="4321080"/>
              <a:ext cx="427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ALL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Straight Connector 7"/>
            <p:cNvSpPr/>
            <p:nvPr/>
          </p:nvSpPr>
          <p:spPr>
            <a:xfrm>
              <a:off x="2150640" y="4498920"/>
              <a:ext cx="306360" cy="0"/>
            </a:xfrm>
            <a:prstGeom prst="line">
              <a:avLst/>
            </a:prstGeom>
            <a:ln w="2844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TextBox 72"/>
            <p:cNvSpPr/>
            <p:nvPr/>
          </p:nvSpPr>
          <p:spPr>
            <a:xfrm>
              <a:off x="4651200" y="2845080"/>
              <a:ext cx="478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ffffff"/>
                  </a:solidFill>
                  <a:latin typeface="Times New Roman"/>
                  <a:ea typeface="MS PGothic"/>
                </a:rPr>
                <a:t>Mock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Straight Connector 7"/>
            <p:cNvSpPr/>
            <p:nvPr/>
          </p:nvSpPr>
          <p:spPr>
            <a:xfrm>
              <a:off x="3647880" y="4503960"/>
              <a:ext cx="304560" cy="0"/>
            </a:xfrm>
            <a:prstGeom prst="line">
              <a:avLst/>
            </a:prstGeom>
            <a:ln w="28440">
              <a:solidFill>
                <a:srgbClr val="ffff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63" name="Rectangle 29"/>
          <p:cNvSpPr/>
          <p:nvPr/>
        </p:nvSpPr>
        <p:spPr>
          <a:xfrm>
            <a:off x="314280" y="4756320"/>
            <a:ext cx="6227640" cy="105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Figure S4 | HIF1-α expression by CoCl</a:t>
            </a:r>
            <a:r>
              <a:rPr b="1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 </a:t>
            </a:r>
            <a:r>
              <a:rPr b="1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treated mesenchymal stromal cells (MSC) from normal and acute lymphoblastic leukemia (ALL) bone marrow. 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HIF-1α was evaluated by immunofluorescence in standard culture conditions (upper panel) and hypoxic-like conditions induced by treatment with CoCl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2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 [100μM] for 2 hours (lower panel) (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NBM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4, N</a:t>
            </a:r>
            <a:r>
              <a:rPr b="0" lang="en-US" sz="1200" spc="-1" strike="noStrike" baseline="-25000">
                <a:solidFill>
                  <a:srgbClr val="000000"/>
                </a:solidFill>
                <a:latin typeface="Times New Roman"/>
                <a:ea typeface="Times New Roman"/>
              </a:rPr>
              <a:t>ALL</a:t>
            </a:r>
            <a:r>
              <a:rPr b="0" lang="en-US" sz="1200" spc="-1" strike="noStrike">
                <a:solidFill>
                  <a:srgbClr val="000000"/>
                </a:solidFill>
                <a:latin typeface="Times New Roman"/>
                <a:ea typeface="Times New Roman"/>
              </a:rPr>
              <a:t>=5). NBM: Normal Bone Marrow; ALL: Acute Lymphoblastic Leukemia.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12-12T03:08:14Z</dcterms:created>
  <dc:creator>PELAYO</dc:creator>
  <dc:description/>
  <dc:language>en-US</dc:language>
  <cp:lastModifiedBy>PELAYO</cp:lastModifiedBy>
  <dcterms:modified xsi:type="dcterms:W3CDTF">2016-12-14T20:28:36Z</dcterms:modified>
  <cp:revision>6</cp:revision>
  <dc:subject/>
  <dc:title>Diapositiva 1</dc:title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DocumentId">
    <vt:lpwstr>Presentation 4.PPT</vt:lpwstr>
  </property>
  <property fmtid="{D5CDD505-2E9C-101B-9397-08002B2CF9AE}" pid="3" name="DocumentType">
    <vt:lpwstr>Presentation</vt:lpwstr>
  </property>
  <property fmtid="{D5CDD505-2E9C-101B-9397-08002B2CF9AE}" pid="4" name="FileFormat">
    <vt:lpwstr>PPT</vt:lpwstr>
  </property>
  <property fmtid="{D5CDD505-2E9C-101B-9397-08002B2CF9AE}" pid="5" name="TitleName">
    <vt:lpwstr>Presentation 4.PPT</vt:lpwstr>
  </property>
</Properties>
</file>